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1837F8-A47B-4FBD-9782-BB70D9CF0337}" type="slidenum">
              <a:rPr b="0" lang="pt-B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8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pt-B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Espaço Reservado para Número de Slid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620316-0267-4BD2-9DBA-F4722FB59FB4}" type="slidenum">
              <a:rPr b="0" lang="pt-B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9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Espaço Reservado para Número de Slid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A4044A-3D8F-4729-9A7D-7AFC1935B4AC}" type="slidenum">
              <a:rPr b="0" lang="pt-B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9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pt-B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Espaço Reservado para Número de Slid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0EA4CFD-8450-4274-B754-67A1BBE27201}" type="slidenum">
              <a:rPr b="0" lang="pt-B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2C91D-E821-4030-90F3-1E203AAF7CB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64354D-14CE-43C4-AB3F-FEEF9C27A5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E61D94-95AE-478D-BE38-FCD63FEFB3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48EC84-6220-46E1-BA11-1BB6218BB3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96FD6-1C40-46AD-99EF-E05A1684CF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83BE97-895B-4860-8538-36BBA3B486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C35D46-4222-42B8-A7FB-A729EB11D4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518F39-E414-4BA4-BFAA-DAC836406B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D3AD5A-7722-466C-A212-FCD8EB609E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AD5BC2-F6D9-4478-82D1-CF86A2ADF7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9CE8BB-BF02-41F4-ABCB-BD7D5A933D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55E249-76A5-40BE-AB29-BB56D3E00B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8A91CF-EC9B-4052-820C-E0D1C3277422}" type="slidenum">
              <a:rPr b="0" lang="pt-B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image" Target="../media/image7.png"/><Relationship Id="rId14" Type="http://schemas.openxmlformats.org/officeDocument/2006/relationships/slideLayout" Target="../slideLayouts/slideLayout1.xml"/><Relationship Id="rId15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5"/>
          <p:cNvGraphicFramePr/>
          <p:nvPr/>
        </p:nvGraphicFramePr>
        <p:xfrm>
          <a:off x="1719360" y="1049400"/>
          <a:ext cx="1439640" cy="12333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Object 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19360" y="1049400"/>
                    <a:ext cx="1439640" cy="1233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0" name="Object 6"/>
          <p:cNvGraphicFramePr/>
          <p:nvPr/>
        </p:nvGraphicFramePr>
        <p:xfrm>
          <a:off x="1719360" y="2313000"/>
          <a:ext cx="1439640" cy="12333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1" name="Object 6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719360" y="2313000"/>
                    <a:ext cx="1439640" cy="1233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2" name="Object 7"/>
          <p:cNvGraphicFramePr/>
          <p:nvPr/>
        </p:nvGraphicFramePr>
        <p:xfrm>
          <a:off x="3232080" y="2324160"/>
          <a:ext cx="1440000" cy="12333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3" name="Object 7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232080" y="2324160"/>
                    <a:ext cx="1440000" cy="1233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4" name="Object 8"/>
          <p:cNvGraphicFramePr/>
          <p:nvPr/>
        </p:nvGraphicFramePr>
        <p:xfrm>
          <a:off x="4726080" y="2317680"/>
          <a:ext cx="1439640" cy="123372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55" name="Object 8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4726080" y="2317680"/>
                    <a:ext cx="1439640" cy="1233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6" name="Object 9"/>
          <p:cNvGraphicFramePr/>
          <p:nvPr/>
        </p:nvGraphicFramePr>
        <p:xfrm>
          <a:off x="3232080" y="1049400"/>
          <a:ext cx="1440000" cy="123336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57" name="Object 9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3232080" y="1049400"/>
                    <a:ext cx="1440000" cy="1233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8" name="Object 10"/>
          <p:cNvGraphicFramePr/>
          <p:nvPr/>
        </p:nvGraphicFramePr>
        <p:xfrm>
          <a:off x="4719600" y="1049400"/>
          <a:ext cx="1440000" cy="123336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59" name="Object 10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4719600" y="1049400"/>
                    <a:ext cx="1440000" cy="1233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0" name="Text Box 11"/>
          <p:cNvSpPr/>
          <p:nvPr/>
        </p:nvSpPr>
        <p:spPr>
          <a:xfrm>
            <a:off x="1431720" y="611280"/>
            <a:ext cx="4969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Wild-type    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pt-BR" sz="18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</a:rPr>
              <a:t>pmcA::pmcA</a:t>
            </a:r>
            <a:r>
              <a:rPr b="0" i="1" lang="pt-BR" sz="18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pt-BR" sz="18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pmcA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    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3"/>
          <p:cNvSpPr/>
          <p:nvPr/>
        </p:nvSpPr>
        <p:spPr>
          <a:xfrm>
            <a:off x="270000" y="1465200"/>
            <a:ext cx="1282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YAG 37 </a:t>
            </a:r>
            <a:r>
              <a:rPr b="0" lang="pt-BR" sz="1800" spc="-1" strike="noStrike" baseline="30000">
                <a:solidFill>
                  <a:srgbClr val="000000"/>
                </a:solidFill>
                <a:latin typeface="Arial"/>
              </a:rPr>
              <a:t>o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2" name="Grupo 19"/>
          <p:cNvGrpSpPr/>
          <p:nvPr/>
        </p:nvGrpSpPr>
        <p:grpSpPr>
          <a:xfrm>
            <a:off x="2060640" y="6265800"/>
            <a:ext cx="4680720" cy="2522520"/>
            <a:chOff x="2060640" y="6265800"/>
            <a:chExt cx="4680720" cy="2522520"/>
          </a:xfrm>
        </p:grpSpPr>
        <p:pic>
          <p:nvPicPr>
            <p:cNvPr id="63" name="Imagem 13" descr="pcr conf comple 170811 editado.tif"/>
            <p:cNvPicPr/>
            <p:nvPr/>
          </p:nvPicPr>
          <p:blipFill>
            <a:blip r:embed="rId13"/>
            <a:stretch/>
          </p:blipFill>
          <p:spPr>
            <a:xfrm>
              <a:off x="2060640" y="6265800"/>
              <a:ext cx="2161080" cy="252252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64" name="Conector de seta reta 17"/>
            <p:cNvCxnSpPr/>
            <p:nvPr/>
          </p:nvCxnSpPr>
          <p:spPr>
            <a:xfrm flipH="1" flipV="1">
              <a:off x="4349160" y="6698880"/>
              <a:ext cx="30060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65" name="CaixaDeTexto 19"/>
            <p:cNvSpPr/>
            <p:nvPr/>
          </p:nvSpPr>
          <p:spPr>
            <a:xfrm>
              <a:off x="4667760" y="6553440"/>
              <a:ext cx="2073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800" spc="-1" strike="noStrike">
                  <a:solidFill>
                    <a:srgbClr val="000000"/>
                  </a:solidFill>
                  <a:latin typeface="Arial"/>
                </a:rPr>
                <a:t>ORF </a:t>
              </a:r>
              <a:r>
                <a:rPr b="0" i="1" lang="pt-BR" sz="1800" spc="-1" strike="noStrike">
                  <a:solidFill>
                    <a:srgbClr val="000000"/>
                  </a:solidFill>
                  <a:latin typeface="Arial"/>
                </a:rPr>
                <a:t>pmcA </a:t>
              </a:r>
              <a:r>
                <a:rPr b="0" lang="pt-BR" sz="1800" spc="-1" strike="noStrike">
                  <a:solidFill>
                    <a:srgbClr val="000000"/>
                  </a:solidFill>
                  <a:latin typeface="Arial"/>
                </a:rPr>
                <a:t> 4.3-k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CaixaDeTexto 16"/>
          <p:cNvSpPr/>
          <p:nvPr/>
        </p:nvSpPr>
        <p:spPr>
          <a:xfrm>
            <a:off x="185040" y="-108000"/>
            <a:ext cx="5648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32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CaixaDeTexto 18"/>
          <p:cNvSpPr/>
          <p:nvPr/>
        </p:nvSpPr>
        <p:spPr>
          <a:xfrm>
            <a:off x="196200" y="3699000"/>
            <a:ext cx="5648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32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CaixaDeTexto 20"/>
          <p:cNvSpPr/>
          <p:nvPr/>
        </p:nvSpPr>
        <p:spPr>
          <a:xfrm rot="16200000">
            <a:off x="2309400" y="5500080"/>
            <a:ext cx="91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8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</a:rPr>
              <a:t>pmc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Conector reto 22"/>
          <p:cNvSpPr/>
          <p:nvPr/>
        </p:nvSpPr>
        <p:spPr>
          <a:xfrm>
            <a:off x="2584440" y="6180120"/>
            <a:ext cx="43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Conector reto 23"/>
          <p:cNvSpPr/>
          <p:nvPr/>
        </p:nvSpPr>
        <p:spPr>
          <a:xfrm>
            <a:off x="3160800" y="6170760"/>
            <a:ext cx="43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Conector reto 24"/>
          <p:cNvSpPr/>
          <p:nvPr/>
        </p:nvSpPr>
        <p:spPr>
          <a:xfrm>
            <a:off x="3732120" y="6170760"/>
            <a:ext cx="432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CaixaDeTexto 25"/>
          <p:cNvSpPr/>
          <p:nvPr/>
        </p:nvSpPr>
        <p:spPr>
          <a:xfrm rot="16200000">
            <a:off x="3046320" y="5112360"/>
            <a:ext cx="1707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8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</a:rPr>
              <a:t>pmcA::pmcA</a:t>
            </a:r>
            <a:r>
              <a:rPr b="0" i="1" lang="pt-BR" sz="18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CaixaDeTexto 26"/>
          <p:cNvSpPr/>
          <p:nvPr/>
        </p:nvSpPr>
        <p:spPr>
          <a:xfrm rot="16200000">
            <a:off x="2807280" y="5404320"/>
            <a:ext cx="113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Wild-typ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13"/>
          <p:cNvSpPr/>
          <p:nvPr/>
        </p:nvSpPr>
        <p:spPr>
          <a:xfrm>
            <a:off x="304200" y="2424240"/>
            <a:ext cx="1282320" cy="122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YAG 37 </a:t>
            </a:r>
            <a:r>
              <a:rPr b="0" lang="pt-BR" sz="1800" spc="-1" strike="noStrike" baseline="30000">
                <a:solidFill>
                  <a:srgbClr val="000000"/>
                </a:solidFill>
                <a:latin typeface="Arial"/>
              </a:rPr>
              <a:t>o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CaCl</a:t>
            </a:r>
            <a:r>
              <a:rPr b="0" lang="pt-BR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500m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Group 11"/>
          <p:cNvGrpSpPr/>
          <p:nvPr/>
        </p:nvGrpSpPr>
        <p:grpSpPr>
          <a:xfrm>
            <a:off x="1628640" y="2233440"/>
            <a:ext cx="2509920" cy="3143160"/>
            <a:chOff x="1628640" y="2233440"/>
            <a:chExt cx="2509920" cy="3143160"/>
          </a:xfrm>
        </p:grpSpPr>
        <p:pic>
          <p:nvPicPr>
            <p:cNvPr id="76" name="Picture 4" descr="pcr pmcbc"/>
            <p:cNvPicPr/>
            <p:nvPr/>
          </p:nvPicPr>
          <p:blipFill>
            <a:blip r:embed="rId1"/>
            <a:srcRect l="39442" t="6436" r="0" b="0"/>
            <a:stretch/>
          </p:blipFill>
          <p:spPr>
            <a:xfrm>
              <a:off x="2349360" y="2233440"/>
              <a:ext cx="1789200" cy="3140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Imagem 7" descr="pcr conf comple 170811 editado.tif"/>
            <p:cNvPicPr/>
            <p:nvPr/>
          </p:nvPicPr>
          <p:blipFill>
            <a:blip r:embed="rId2"/>
            <a:srcRect l="0" t="0" r="69907" b="6334"/>
            <a:stretch/>
          </p:blipFill>
          <p:spPr>
            <a:xfrm>
              <a:off x="1628640" y="2236680"/>
              <a:ext cx="777960" cy="3139920"/>
            </a:xfrm>
            <a:prstGeom prst="rect">
              <a:avLst/>
            </a:prstGeom>
            <a:ln w="0">
              <a:noFill/>
            </a:ln>
          </p:spPr>
        </p:pic>
      </p:grpSp>
      <p:cxnSp>
        <p:nvCxnSpPr>
          <p:cNvPr id="78" name="Conector de seta reta 4"/>
          <p:cNvCxnSpPr/>
          <p:nvPr/>
        </p:nvCxnSpPr>
        <p:spPr>
          <a:xfrm flipH="1" flipV="1">
            <a:off x="4220280" y="2858760"/>
            <a:ext cx="35964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9" name="CaixaDeTexto 19"/>
          <p:cNvSpPr/>
          <p:nvPr/>
        </p:nvSpPr>
        <p:spPr>
          <a:xfrm>
            <a:off x="4559400" y="2665440"/>
            <a:ext cx="2009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ORF 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</a:rPr>
              <a:t>pmcB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 3.5-k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CaixaDeTexto 18"/>
          <p:cNvSpPr/>
          <p:nvPr/>
        </p:nvSpPr>
        <p:spPr>
          <a:xfrm>
            <a:off x="195840" y="324000"/>
            <a:ext cx="58752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3200" spc="-1" strike="noStrike">
                <a:solidFill>
                  <a:srgbClr val="000000"/>
                </a:solidFill>
                <a:latin typeface="Arial"/>
              </a:rPr>
              <a:t>C.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CaixaDeTexto 20"/>
          <p:cNvSpPr/>
          <p:nvPr/>
        </p:nvSpPr>
        <p:spPr>
          <a:xfrm rot="16200000">
            <a:off x="2122200" y="1467720"/>
            <a:ext cx="91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8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</a:rPr>
              <a:t>pmc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Conector reto 10"/>
          <p:cNvSpPr/>
          <p:nvPr/>
        </p:nvSpPr>
        <p:spPr>
          <a:xfrm>
            <a:off x="2398680" y="2147760"/>
            <a:ext cx="432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Conector reto 11"/>
          <p:cNvSpPr/>
          <p:nvPr/>
        </p:nvSpPr>
        <p:spPr>
          <a:xfrm>
            <a:off x="2975040" y="2138400"/>
            <a:ext cx="43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Conector reto 12"/>
          <p:cNvSpPr/>
          <p:nvPr/>
        </p:nvSpPr>
        <p:spPr>
          <a:xfrm>
            <a:off x="3546360" y="2138400"/>
            <a:ext cx="432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CaixaDeTexto 25"/>
          <p:cNvSpPr/>
          <p:nvPr/>
        </p:nvSpPr>
        <p:spPr>
          <a:xfrm rot="16200000">
            <a:off x="2860560" y="1080000"/>
            <a:ext cx="1707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8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</a:rPr>
              <a:t>pmcB::pmcB</a:t>
            </a:r>
            <a:r>
              <a:rPr b="0" i="1" lang="pt-BR" sz="18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CaixaDeTexto 26"/>
          <p:cNvSpPr/>
          <p:nvPr/>
        </p:nvSpPr>
        <p:spPr>
          <a:xfrm rot="16200000">
            <a:off x="2621520" y="1371960"/>
            <a:ext cx="113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Wild-typ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CaixaDeTexto 1"/>
          <p:cNvSpPr/>
          <p:nvPr/>
        </p:nvSpPr>
        <p:spPr>
          <a:xfrm>
            <a:off x="78480" y="611280"/>
            <a:ext cx="6586200" cy="122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Supplementary Figure S6 – (A) Growth phenotype of th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8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</a:rPr>
              <a:t>pmcA::pmcA</a:t>
            </a:r>
            <a:r>
              <a:rPr b="0" i="1" lang="pt-BR" sz="18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  strain grown on YAG+CaCl</a:t>
            </a:r>
            <a:r>
              <a:rPr b="0" lang="pt-BR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 500 mM. (B) PC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of the 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</a:rPr>
              <a:t>pmcA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 open reading frame. (C) PCR of the 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</a:rPr>
              <a:t>pmcB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 open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reading fram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25T11:35:11Z</dcterms:created>
  <dc:creator>user</dc:creator>
  <dc:description/>
  <dc:language>en-US</dc:language>
  <cp:lastModifiedBy>Goldman</cp:lastModifiedBy>
  <dcterms:modified xsi:type="dcterms:W3CDTF">2012-05-01T17:49:03Z</dcterms:modified>
  <cp:revision>10</cp:revision>
  <dc:subject/>
  <dc:title>Slide 1</dc:title>
</cp:coreProperties>
</file>